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60" r:id="rId1"/>
  </p:sldMasterIdLst>
  <p:notesMasterIdLst>
    <p:notesMasterId r:id="rId7"/>
  </p:notesMasterIdLst>
  <p:sldIdLst>
    <p:sldId id="1978" r:id="rId2"/>
    <p:sldId id="1985" r:id="rId3"/>
    <p:sldId id="1967" r:id="rId4"/>
    <p:sldId id="1984" r:id="rId5"/>
    <p:sldId id="1994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798" userDrawn="1">
          <p15:clr>
            <a:srgbClr val="A4A3A4"/>
          </p15:clr>
        </p15:guide>
        <p15:guide id="2" pos="7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6875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4104" y="102"/>
      </p:cViewPr>
      <p:guideLst>
        <p:guide orient="horz" pos="4798"/>
        <p:guide pos="7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3CBC2A1-7ACA-4C07-B4B9-A4079A948BEF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97CA8C-64A5-40C8-B51D-4834CD78758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72126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16C4B-9B6B-4FCE-B2FC-B4AE78041177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D023C-F23E-43AF-883B-F88EACCE87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7622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16C4B-9B6B-4FCE-B2FC-B4AE78041177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D023C-F23E-43AF-883B-F88EACCE87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5264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16C4B-9B6B-4FCE-B2FC-B4AE78041177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D023C-F23E-43AF-883B-F88EACCE87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3446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二级</a:t>
            </a:r>
          </a:p>
          <a:p>
            <a:pPr lvl="2"/>
            <a:r>
              <a:rPr lang="zh-CN" altLang="en-US" dirty="0"/>
              <a:t>三级</a:t>
            </a:r>
          </a:p>
          <a:p>
            <a:pPr lvl="3"/>
            <a:r>
              <a:rPr lang="zh-CN" altLang="en-US" dirty="0"/>
              <a:t>四级</a:t>
            </a:r>
          </a:p>
          <a:p>
            <a:pPr lvl="4"/>
            <a:r>
              <a:rPr lang="zh-CN" altLang="en-US" dirty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16C4B-9B6B-4FCE-B2FC-B4AE78041177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D023C-F23E-43AF-883B-F88EACCE87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692220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16C4B-9B6B-4FCE-B2FC-B4AE78041177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D023C-F23E-43AF-883B-F88EACCE87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82946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16C4B-9B6B-4FCE-B2FC-B4AE78041177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D023C-F23E-43AF-883B-F88EACCE87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31899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16C4B-9B6B-4FCE-B2FC-B4AE78041177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D023C-F23E-43AF-883B-F88EACCE87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678557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16C4B-9B6B-4FCE-B2FC-B4AE78041177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D023C-F23E-43AF-883B-F88EACCE87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1708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16C4B-9B6B-4FCE-B2FC-B4AE78041177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D023C-F23E-43AF-883B-F88EACCE87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141974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16C4B-9B6B-4FCE-B2FC-B4AE78041177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D023C-F23E-43AF-883B-F88EACCE87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4337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616C4B-9B6B-4FCE-B2FC-B4AE78041177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DD023C-F23E-43AF-883B-F88EACCE87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5050030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616C4B-9B6B-4FCE-B2FC-B4AE78041177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DD023C-F23E-43AF-883B-F88EACCE879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84128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3120" userDrawn="1">
          <p15:clr>
            <a:srgbClr val="F26B43"/>
          </p15:clr>
        </p15:guide>
        <p15:guide id="2" pos="2160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矩形 17">
            <a:extLst>
              <a:ext uri="{FF2B5EF4-FFF2-40B4-BE49-F238E27FC236}">
                <a16:creationId xmlns="" xmlns:a16="http://schemas.microsoft.com/office/drawing/2014/main" id="{A70E409A-6528-4714-99F4-E7BC7B74D350}"/>
              </a:ext>
            </a:extLst>
          </p:cNvPr>
          <p:cNvSpPr/>
          <p:nvPr/>
        </p:nvSpPr>
        <p:spPr>
          <a:xfrm>
            <a:off x="106731" y="473453"/>
            <a:ext cx="625350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. Generation of </a:t>
            </a:r>
            <a:r>
              <a:rPr lang="en-US" altLang="zh-CN" sz="1400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SCaBP8 </a:t>
            </a:r>
            <a:r>
              <a:rPr lang="en-US" altLang="zh-CN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utants via CRISPR/Cas9-based approach</a:t>
            </a:r>
            <a:endParaRPr lang="zh-CN" altLang="zh-CN" sz="1400" b="1" dirty="0"/>
          </a:p>
        </p:txBody>
      </p:sp>
      <p:grpSp>
        <p:nvGrpSpPr>
          <p:cNvPr id="64" name="组合 63">
            <a:extLst>
              <a:ext uri="{FF2B5EF4-FFF2-40B4-BE49-F238E27FC236}">
                <a16:creationId xmlns="" xmlns:a16="http://schemas.microsoft.com/office/drawing/2014/main" id="{AA8D5855-AE09-4A84-9645-FC6E02ABA41D}"/>
              </a:ext>
            </a:extLst>
          </p:cNvPr>
          <p:cNvGrpSpPr/>
          <p:nvPr/>
        </p:nvGrpSpPr>
        <p:grpSpPr>
          <a:xfrm>
            <a:off x="164279" y="1204063"/>
            <a:ext cx="6529441" cy="3140352"/>
            <a:chOff x="2274199" y="2039275"/>
            <a:chExt cx="6529441" cy="3140352"/>
          </a:xfrm>
        </p:grpSpPr>
        <p:pic>
          <p:nvPicPr>
            <p:cNvPr id="65" name="图片 64">
              <a:extLst>
                <a:ext uri="{FF2B5EF4-FFF2-40B4-BE49-F238E27FC236}">
                  <a16:creationId xmlns="" xmlns:a16="http://schemas.microsoft.com/office/drawing/2014/main" id="{5DCCC97B-746C-4A5B-8D2B-A63D8B4B22D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327628" y="2225353"/>
              <a:ext cx="5163607" cy="601760"/>
            </a:xfrm>
            <a:prstGeom prst="rect">
              <a:avLst/>
            </a:prstGeom>
          </p:spPr>
        </p:pic>
        <p:grpSp>
          <p:nvGrpSpPr>
            <p:cNvPr id="66" name="组合 65">
              <a:extLst>
                <a:ext uri="{FF2B5EF4-FFF2-40B4-BE49-F238E27FC236}">
                  <a16:creationId xmlns="" xmlns:a16="http://schemas.microsoft.com/office/drawing/2014/main" id="{C822554C-4D37-4AB1-8599-6EEEA31B6B7D}"/>
                </a:ext>
              </a:extLst>
            </p:cNvPr>
            <p:cNvGrpSpPr/>
            <p:nvPr/>
          </p:nvGrpSpPr>
          <p:grpSpPr>
            <a:xfrm>
              <a:off x="2274199" y="2775524"/>
              <a:ext cx="6529441" cy="738742"/>
              <a:chOff x="2274199" y="2775524"/>
              <a:chExt cx="6529441" cy="738742"/>
            </a:xfrm>
          </p:grpSpPr>
          <p:sp>
            <p:nvSpPr>
              <p:cNvPr id="71" name="文本框 70">
                <a:extLst>
                  <a:ext uri="{FF2B5EF4-FFF2-40B4-BE49-F238E27FC236}">
                    <a16:creationId xmlns="" xmlns:a16="http://schemas.microsoft.com/office/drawing/2014/main" id="{8E2F13F5-4057-4327-ABC2-6F1A9305DAF0}"/>
                  </a:ext>
                </a:extLst>
              </p:cNvPr>
              <p:cNvSpPr txBox="1"/>
              <p:nvPr/>
            </p:nvSpPr>
            <p:spPr>
              <a:xfrm>
                <a:off x="4248390" y="2775524"/>
                <a:ext cx="68538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gRNA1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文本框 71">
                <a:extLst>
                  <a:ext uri="{FF2B5EF4-FFF2-40B4-BE49-F238E27FC236}">
                    <a16:creationId xmlns="" xmlns:a16="http://schemas.microsoft.com/office/drawing/2014/main" id="{8A307A18-09A4-4F4D-A302-5B4CC8ED0DC6}"/>
                  </a:ext>
                </a:extLst>
              </p:cNvPr>
              <p:cNvSpPr txBox="1"/>
              <p:nvPr/>
            </p:nvSpPr>
            <p:spPr>
              <a:xfrm>
                <a:off x="6921596" y="2779942"/>
                <a:ext cx="68538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gRNA2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73" name="组合 72">
                <a:extLst>
                  <a:ext uri="{FF2B5EF4-FFF2-40B4-BE49-F238E27FC236}">
                    <a16:creationId xmlns="" xmlns:a16="http://schemas.microsoft.com/office/drawing/2014/main" id="{00FFD237-B003-4F83-A572-8432B106E044}"/>
                  </a:ext>
                </a:extLst>
              </p:cNvPr>
              <p:cNvGrpSpPr/>
              <p:nvPr/>
            </p:nvGrpSpPr>
            <p:grpSpPr>
              <a:xfrm>
                <a:off x="2274199" y="2850916"/>
                <a:ext cx="6529441" cy="663350"/>
                <a:chOff x="2274199" y="2850916"/>
                <a:chExt cx="6529441" cy="663350"/>
              </a:xfrm>
            </p:grpSpPr>
            <p:sp>
              <p:nvSpPr>
                <p:cNvPr id="74" name="文本框 73">
                  <a:extLst>
                    <a:ext uri="{FF2B5EF4-FFF2-40B4-BE49-F238E27FC236}">
                      <a16:creationId xmlns="" xmlns:a16="http://schemas.microsoft.com/office/drawing/2014/main" id="{D3B74A0D-7AF0-42BB-A7EF-38F3B39D0721}"/>
                    </a:ext>
                  </a:extLst>
                </p:cNvPr>
                <p:cNvSpPr txBox="1"/>
                <p:nvPr/>
              </p:nvSpPr>
              <p:spPr>
                <a:xfrm>
                  <a:off x="2274199" y="2960268"/>
                  <a:ext cx="933521" cy="5539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zh-CN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82</a:t>
                  </a:r>
                </a:p>
                <a:p>
                  <a:pPr algn="r"/>
                  <a:r>
                    <a:rPr lang="en-US" altLang="zh-CN" sz="10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lscabp8-cr-1</a:t>
                  </a:r>
                </a:p>
                <a:p>
                  <a:pPr algn="r"/>
                  <a:r>
                    <a:rPr lang="en-US" altLang="zh-CN" sz="1000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slscabp8-cr-2</a:t>
                  </a:r>
                  <a:endParaRPr lang="zh-CN" altLang="en-US" sz="1000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5" name="矩形 74">
                  <a:extLst>
                    <a:ext uri="{FF2B5EF4-FFF2-40B4-BE49-F238E27FC236}">
                      <a16:creationId xmlns="" xmlns:a16="http://schemas.microsoft.com/office/drawing/2014/main" id="{47394DE0-3281-4A20-9CD2-3E0E3504ABB6}"/>
                    </a:ext>
                  </a:extLst>
                </p:cNvPr>
                <p:cNvSpPr/>
                <p:nvPr/>
              </p:nvSpPr>
              <p:spPr>
                <a:xfrm>
                  <a:off x="3087813" y="2960268"/>
                  <a:ext cx="5715827" cy="553998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CC</a:t>
                  </a:r>
                  <a:r>
                    <a:rPr lang="en-US" altLang="zh-CN" sz="1000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CA</a:t>
                  </a:r>
                  <a:r>
                    <a:rPr lang="en-US" altLang="zh-CN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TATTGCACTCATTGAAGCTTG(N69)GGA</a:t>
                  </a:r>
                  <a:r>
                    <a:rPr lang="en-US" altLang="zh-CN" sz="1000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CT</a:t>
                  </a:r>
                  <a:r>
                    <a:rPr lang="en-US" altLang="zh-CN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GCT  CGACTTGCCGGGGAATCT</a:t>
                  </a:r>
                </a:p>
                <a:p>
                  <a:r>
                    <a:rPr lang="en-US" altLang="zh-CN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CC</a:t>
                  </a:r>
                  <a:r>
                    <a:rPr lang="en-US" altLang="zh-CN" sz="1000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CA</a:t>
                  </a:r>
                  <a:r>
                    <a:rPr lang="en-US" altLang="zh-CN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TATTGCACTCATTGAAGCTTG(N69)GGA</a:t>
                  </a:r>
                  <a:r>
                    <a:rPr lang="en-US" altLang="zh-CN" sz="1000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CT</a:t>
                  </a:r>
                  <a:r>
                    <a:rPr lang="en-US" altLang="zh-CN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GCT</a:t>
                  </a:r>
                  <a:r>
                    <a:rPr lang="en-US" altLang="zh-CN" sz="1000" dirty="0">
                      <a:solidFill>
                        <a:srgbClr val="FF0000"/>
                      </a:solidFill>
                      <a:highlight>
                        <a:srgbClr val="FFFF00"/>
                      </a:highlight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</a:t>
                  </a:r>
                  <a:r>
                    <a:rPr lang="en-US" altLang="zh-CN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GACTTGCCGGGGAATCT + 1bp</a:t>
                  </a:r>
                </a:p>
                <a:p>
                  <a:r>
                    <a:rPr lang="en-US" altLang="zh-CN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CC</a:t>
                  </a:r>
                  <a:r>
                    <a:rPr lang="en-US" altLang="zh-CN" sz="1000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CA</a:t>
                  </a:r>
                  <a:r>
                    <a:rPr lang="en-US" altLang="zh-CN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TAT -----------------------------------(N69)--------------------- CGACTTGCCGGGGAATCT - 97bp</a:t>
                  </a:r>
                  <a:endParaRPr lang="zh-CN" alt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76" name="直接连接符 75">
                  <a:extLst>
                    <a:ext uri="{FF2B5EF4-FFF2-40B4-BE49-F238E27FC236}">
                      <a16:creationId xmlns="" xmlns:a16="http://schemas.microsoft.com/office/drawing/2014/main" id="{BD73FAFA-DFC8-48DA-8741-50C4A49BAD8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725039" y="2997465"/>
                  <a:ext cx="1570587" cy="0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7" name="直接连接符 76">
                  <a:extLst>
                    <a:ext uri="{FF2B5EF4-FFF2-40B4-BE49-F238E27FC236}">
                      <a16:creationId xmlns="" xmlns:a16="http://schemas.microsoft.com/office/drawing/2014/main" id="{F2E325DB-49F2-4B97-8007-EA1B4C65D44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419340" y="2996345"/>
                  <a:ext cx="1658909" cy="0"/>
                </a:xfrm>
                <a:prstGeom prst="line">
                  <a:avLst/>
                </a:prstGeom>
                <a:ln w="952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78" name="文本框 77">
                  <a:extLst>
                    <a:ext uri="{FF2B5EF4-FFF2-40B4-BE49-F238E27FC236}">
                      <a16:creationId xmlns="" xmlns:a16="http://schemas.microsoft.com/office/drawing/2014/main" id="{BF124498-6CF5-4174-AE8F-8B3922B59C98}"/>
                    </a:ext>
                  </a:extLst>
                </p:cNvPr>
                <p:cNvSpPr txBox="1"/>
                <p:nvPr/>
              </p:nvSpPr>
              <p:spPr>
                <a:xfrm>
                  <a:off x="3337788" y="2850916"/>
                  <a:ext cx="47975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AM</a:t>
                  </a:r>
                  <a:endParaRPr lang="zh-CN" alt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9" name="文本框 78">
                  <a:extLst>
                    <a:ext uri="{FF2B5EF4-FFF2-40B4-BE49-F238E27FC236}">
                      <a16:creationId xmlns="" xmlns:a16="http://schemas.microsoft.com/office/drawing/2014/main" id="{0B6EDAF3-0933-487E-91A3-1AD63AA7D5E5}"/>
                    </a:ext>
                  </a:extLst>
                </p:cNvPr>
                <p:cNvSpPr txBox="1"/>
                <p:nvPr/>
              </p:nvSpPr>
              <p:spPr>
                <a:xfrm>
                  <a:off x="6040081" y="2850916"/>
                  <a:ext cx="47975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PAM</a:t>
                  </a:r>
                  <a:endParaRPr lang="zh-CN" alt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sp>
          <p:nvSpPr>
            <p:cNvPr id="67" name="矩形 66">
              <a:extLst>
                <a:ext uri="{FF2B5EF4-FFF2-40B4-BE49-F238E27FC236}">
                  <a16:creationId xmlns="" xmlns:a16="http://schemas.microsoft.com/office/drawing/2014/main" id="{7C0E61F9-6CD7-4B10-ADC8-4093BB91AF8E}"/>
                </a:ext>
              </a:extLst>
            </p:cNvPr>
            <p:cNvSpPr/>
            <p:nvPr/>
          </p:nvSpPr>
          <p:spPr>
            <a:xfrm>
              <a:off x="2630613" y="3702299"/>
              <a:ext cx="5715826" cy="147732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&gt;M82</a:t>
              </a:r>
            </a:p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STRNSLSWSSLTISEKICASFFPIIALIEACMYAVSGCFECHYPPNKKFSYEYTDLARLAGESRFNVNEVEALYELFKKLSCSIIDDGLIHKEELQLALFQTPHGENLFLDRVFDLFDEKQNGVIEFEEFIHALNIFHPYAPIDDKIDFAFRLYDLRQTGYIEREEVKQMVIAILMESEMRLSDELVEEIIDKTFADADADGDGKIDKKDWKEFAIRYPSLLKNMTLPYLKDITTSFPSFVFHTQVEDIEKIHLL*</a:t>
              </a:r>
            </a:p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&gt;</a:t>
              </a:r>
              <a:r>
                <a:rPr lang="en-US" altLang="zh-CN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scabp8-cr-1</a:t>
              </a:r>
            </a:p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STRNSLSWSSLTISEKICASFFPIIALIEACMYAVSGCFECHYPPNKKFSYEYTDLA</a:t>
              </a:r>
              <a:r>
                <a:rPr lang="en-US" altLang="zh-CN" sz="1000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TCRGISI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</a:p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&gt;</a:t>
              </a:r>
              <a:r>
                <a:rPr lang="en-US" altLang="zh-CN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lscabp8-cr-2</a:t>
              </a:r>
            </a:p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DSTRNSLSWSSLTISEKICASFFPII</a:t>
              </a:r>
              <a:r>
                <a:rPr lang="en-US" altLang="zh-CN" sz="1000" dirty="0">
                  <a:solidFill>
                    <a:srgbClr val="0070C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LPGNLDLM</a:t>
              </a:r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8" name="直接连接符 67">
              <a:extLst>
                <a:ext uri="{FF2B5EF4-FFF2-40B4-BE49-F238E27FC236}">
                  <a16:creationId xmlns="" xmlns:a16="http://schemas.microsoft.com/office/drawing/2014/main" id="{1B013DC2-2565-4122-A5F8-A9770246D0EA}"/>
                </a:ext>
              </a:extLst>
            </p:cNvPr>
            <p:cNvCxnSpPr>
              <a:cxnSpLocks/>
              <a:endCxn id="71" idx="0"/>
            </p:cNvCxnSpPr>
            <p:nvPr/>
          </p:nvCxnSpPr>
          <p:spPr>
            <a:xfrm>
              <a:off x="3596593" y="2556075"/>
              <a:ext cx="994490" cy="219449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接连接符 68">
              <a:extLst>
                <a:ext uri="{FF2B5EF4-FFF2-40B4-BE49-F238E27FC236}">
                  <a16:creationId xmlns="" xmlns:a16="http://schemas.microsoft.com/office/drawing/2014/main" id="{139A4FEA-3BB3-4F94-95E0-B7485B093C71}"/>
                </a:ext>
              </a:extLst>
            </p:cNvPr>
            <p:cNvCxnSpPr>
              <a:cxnSpLocks/>
              <a:endCxn id="72" idx="0"/>
            </p:cNvCxnSpPr>
            <p:nvPr/>
          </p:nvCxnSpPr>
          <p:spPr>
            <a:xfrm>
              <a:off x="3652187" y="2543139"/>
              <a:ext cx="3612102" cy="236803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矩形 69">
              <a:extLst>
                <a:ext uri="{FF2B5EF4-FFF2-40B4-BE49-F238E27FC236}">
                  <a16:creationId xmlns="" xmlns:a16="http://schemas.microsoft.com/office/drawing/2014/main" id="{F641D899-774D-4F55-BF73-C41E2F3470A2}"/>
                </a:ext>
              </a:extLst>
            </p:cNvPr>
            <p:cNvSpPr/>
            <p:nvPr/>
          </p:nvSpPr>
          <p:spPr>
            <a:xfrm>
              <a:off x="2417657" y="2039275"/>
              <a:ext cx="197234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lSCaBP8 </a:t>
              </a:r>
              <a:r>
                <a:rPr lang="en-US" altLang="zh-CN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US" altLang="zh-CN" sz="12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olyc08g065330</a:t>
              </a:r>
              <a:r>
                <a:rPr lang="en-US" altLang="zh-CN" sz="12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lang="zh-CN" altLang="en-US" sz="1200" dirty="0"/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="" xmlns:a16="http://schemas.microsoft.com/office/drawing/2014/main" id="{927285E8-5E57-84BB-2669-DFA5606B8C65}"/>
              </a:ext>
            </a:extLst>
          </p:cNvPr>
          <p:cNvSpPr txBox="1"/>
          <p:nvPr/>
        </p:nvSpPr>
        <p:spPr>
          <a:xfrm>
            <a:off x="205633" y="927064"/>
            <a:ext cx="252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="" xmlns:a16="http://schemas.microsoft.com/office/drawing/2014/main" id="{6989254D-044C-8991-A5F5-A56D1261B7D1}"/>
              </a:ext>
            </a:extLst>
          </p:cNvPr>
          <p:cNvSpPr txBox="1"/>
          <p:nvPr/>
        </p:nvSpPr>
        <p:spPr>
          <a:xfrm>
            <a:off x="207233" y="1826328"/>
            <a:ext cx="252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="" xmlns:a16="http://schemas.microsoft.com/office/drawing/2014/main" id="{EF691C7A-A400-EEAF-5BFF-E1CA5CC103D1}"/>
              </a:ext>
            </a:extLst>
          </p:cNvPr>
          <p:cNvSpPr txBox="1"/>
          <p:nvPr/>
        </p:nvSpPr>
        <p:spPr>
          <a:xfrm>
            <a:off x="205633" y="2774580"/>
            <a:ext cx="252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307737" y="5049531"/>
            <a:ext cx="5997388" cy="22467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. Generation of </a:t>
            </a:r>
            <a:r>
              <a:rPr lang="en-US" altLang="zh-CN" sz="14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lSCaBP8 </a:t>
            </a:r>
            <a:r>
              <a:rPr lang="en-US" altLang="zh-CN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utants via CRISPR/Cas9-based approach</a:t>
            </a:r>
            <a:endParaRPr lang="zh-CN" altLang="zh-CN" sz="14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The schematic of the gene structure of </a:t>
            </a:r>
            <a:r>
              <a:rPr lang="en-US" altLang="zh-CN" sz="14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lSCaBP8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The exons, introns, and UTRs are indicated as black boxes, black lines, and grey boxes, respectively. </a:t>
            </a:r>
            <a:endParaRPr lang="zh-CN" altLang="zh-CN" sz="14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 The </a:t>
            </a:r>
            <a:r>
              <a:rPr lang="en-US" altLang="zh-CN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RNA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equences and gene editing results are listed in the diagram.</a:t>
            </a:r>
            <a:r>
              <a:rPr lang="en-US" altLang="zh-CN" sz="1400" kern="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wo independent single-guide RNAs (sgRNA1 and sgRNA2) were labeled with black lines.</a:t>
            </a:r>
            <a:r>
              <a:rPr lang="en-US" altLang="zh-CN" sz="1400" kern="100" dirty="0">
                <a:solidFill>
                  <a:srgbClr val="000000"/>
                </a:solidFill>
                <a:latin typeface="华文宋体" panose="02010600040101010101" pitchFamily="2" charset="-122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endParaRPr lang="zh-CN" altLang="zh-CN" sz="14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 Alignment of the amino acid sequences of SlSCaBP8 of M82, </a:t>
            </a:r>
            <a:r>
              <a:rPr lang="en-US" altLang="zh-CN" sz="14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lscabp8-cr-1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zh-CN" sz="14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lscabp8-cr-2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The frameshifted sequences of </a:t>
            </a:r>
            <a:r>
              <a:rPr lang="en-US" altLang="zh-CN" sz="14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lscabp8-cr-1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nd </a:t>
            </a:r>
            <a:r>
              <a:rPr lang="en-US" altLang="zh-CN" sz="14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lscabp8-cr-2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were highlighted in blue.</a:t>
            </a:r>
            <a:endParaRPr lang="zh-CN" alt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42323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="" xmlns:a16="http://schemas.microsoft.com/office/drawing/2014/main" id="{9624FE25-B412-1384-40B9-95AE432D3BE6}"/>
              </a:ext>
            </a:extLst>
          </p:cNvPr>
          <p:cNvSpPr/>
          <p:nvPr/>
        </p:nvSpPr>
        <p:spPr>
          <a:xfrm>
            <a:off x="106732" y="473453"/>
            <a:ext cx="5046294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zh-CN" sz="1400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SCaBP8</a:t>
            </a:r>
            <a:r>
              <a:rPr lang="en-US" altLang="zh-CN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egulates Na</a:t>
            </a:r>
            <a:r>
              <a:rPr lang="en-US" altLang="zh-CN" sz="1400" b="1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zh-CN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K</a:t>
            </a:r>
            <a:r>
              <a:rPr lang="en-US" altLang="zh-CN" sz="1400" b="1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ccumulation </a:t>
            </a:r>
            <a:endParaRPr lang="zh-CN" altLang="zh-CN" sz="1400" b="1" dirty="0"/>
          </a:p>
        </p:txBody>
      </p:sp>
      <p:pic>
        <p:nvPicPr>
          <p:cNvPr id="11" name="图片 10">
            <a:extLst>
              <a:ext uri="{FF2B5EF4-FFF2-40B4-BE49-F238E27FC236}">
                <a16:creationId xmlns="" xmlns:a16="http://schemas.microsoft.com/office/drawing/2014/main" id="{604895D3-B8E4-327C-410E-2329DA32E5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9777" y="1254924"/>
            <a:ext cx="3145780" cy="179199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="" xmlns:a16="http://schemas.microsoft.com/office/drawing/2014/main" id="{BEE41AB2-8A05-CF10-FCDE-464E19ECE4B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05427" y="1254924"/>
            <a:ext cx="3145779" cy="179199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="" xmlns:a16="http://schemas.microsoft.com/office/drawing/2014/main" id="{D1EE8A19-2DA1-C77D-2D3B-330D2E27DD9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9777" y="3289348"/>
            <a:ext cx="3145780" cy="1791990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="" xmlns:a16="http://schemas.microsoft.com/office/drawing/2014/main" id="{94C95A92-927C-9EE2-32D0-29D2377E6DCE}"/>
              </a:ext>
            </a:extLst>
          </p:cNvPr>
          <p:cNvSpPr txBox="1"/>
          <p:nvPr/>
        </p:nvSpPr>
        <p:spPr>
          <a:xfrm>
            <a:off x="190752" y="977925"/>
            <a:ext cx="252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="" xmlns:a16="http://schemas.microsoft.com/office/drawing/2014/main" id="{4D1B25BE-95B6-6795-B0BF-4870E8C7FD71}"/>
              </a:ext>
            </a:extLst>
          </p:cNvPr>
          <p:cNvSpPr txBox="1"/>
          <p:nvPr/>
        </p:nvSpPr>
        <p:spPr>
          <a:xfrm>
            <a:off x="3420979" y="977925"/>
            <a:ext cx="252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="" xmlns:a16="http://schemas.microsoft.com/office/drawing/2014/main" id="{649E39FC-CD65-F66E-1180-D4E2D7461640}"/>
              </a:ext>
            </a:extLst>
          </p:cNvPr>
          <p:cNvSpPr txBox="1"/>
          <p:nvPr/>
        </p:nvSpPr>
        <p:spPr>
          <a:xfrm>
            <a:off x="190752" y="2995891"/>
            <a:ext cx="252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="" xmlns:a16="http://schemas.microsoft.com/office/drawing/2014/main" id="{5B952EFB-99AB-AB36-9573-459788C4F749}"/>
              </a:ext>
            </a:extLst>
          </p:cNvPr>
          <p:cNvSpPr/>
          <p:nvPr/>
        </p:nvSpPr>
        <p:spPr>
          <a:xfrm>
            <a:off x="333696" y="5482841"/>
            <a:ext cx="6524304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zh-CN" sz="1400" b="1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SCaBP8</a:t>
            </a:r>
            <a:r>
              <a:rPr lang="en-US" altLang="zh-CN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egulates Na</a:t>
            </a:r>
            <a:r>
              <a:rPr lang="en-US" altLang="zh-CN" sz="1400" b="1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zh-CN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K</a:t>
            </a:r>
            <a:r>
              <a:rPr lang="en-US" altLang="zh-CN" sz="1400" b="1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sz="14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ccumulation</a:t>
            </a:r>
          </a:p>
          <a:p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-(c) The Na</a:t>
            </a:r>
            <a:r>
              <a:rPr lang="en-US" altLang="zh-CN" sz="14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K</a:t>
            </a:r>
            <a:r>
              <a:rPr lang="en-US" altLang="zh-CN" sz="14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ontent in M82 and 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scabp8-cr 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rown under control and saline-alkaline condition (75 mM NaHCO3, pH8.5). Na</a:t>
            </a:r>
            <a:r>
              <a:rPr lang="en-US" altLang="zh-CN" sz="14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ontent (a), K</a:t>
            </a:r>
            <a:r>
              <a:rPr lang="en-US" altLang="zh-CN" sz="14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ontent (b), and Na</a:t>
            </a:r>
            <a:r>
              <a:rPr lang="en-US" altLang="zh-CN" sz="14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/K</a:t>
            </a:r>
            <a:r>
              <a:rPr lang="en-US" altLang="zh-CN" sz="14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atio (c) in M82 and 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lscabp8-cr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ere analyzed in apex, adult leaf (fully developed leaf), stem, and root. The Na</a:t>
            </a:r>
            <a:r>
              <a:rPr lang="en-US" altLang="zh-CN" sz="14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K</a:t>
            </a:r>
            <a:r>
              <a:rPr lang="en-US" altLang="zh-CN" sz="14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contents were measured by inductively coupled plasma-mass spectrometry (ICP-MS).</a:t>
            </a:r>
          </a:p>
          <a:p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experiments were performed with at least three biological replicates with similar results. Statistical signiﬁcance was determined by one-way ANOVA, P &lt; 0.05. Signiﬁcant differences are indicated by different lowercase letters. </a:t>
            </a:r>
          </a:p>
        </p:txBody>
      </p:sp>
    </p:spTree>
    <p:extLst>
      <p:ext uri="{BB962C8B-B14F-4D97-AF65-F5344CB8AC3E}">
        <p14:creationId xmlns:p14="http://schemas.microsoft.com/office/powerpoint/2010/main" val="16869436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="" xmlns:a16="http://schemas.microsoft.com/office/drawing/2014/main" id="{0B1BB3D9-6A82-AFB7-4580-0CEC6913DAAB}"/>
              </a:ext>
            </a:extLst>
          </p:cNvPr>
          <p:cNvSpPr txBox="1"/>
          <p:nvPr/>
        </p:nvSpPr>
        <p:spPr>
          <a:xfrm>
            <a:off x="337443" y="964962"/>
            <a:ext cx="1210322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sequence</a:t>
            </a:r>
            <a:r>
              <a:rPr lang="zh-CN" altLang="en-US" sz="1013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：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="" xmlns:a16="http://schemas.microsoft.com/office/drawing/2014/main" id="{A872D8D1-E285-B256-C0AE-A013B7732A7B}"/>
              </a:ext>
            </a:extLst>
          </p:cNvPr>
          <p:cNvSpPr txBox="1"/>
          <p:nvPr/>
        </p:nvSpPr>
        <p:spPr>
          <a:xfrm>
            <a:off x="127837" y="467607"/>
            <a:ext cx="589196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Sequence variations in amino acids and promoter of </a:t>
            </a:r>
            <a:r>
              <a:rPr lang="en-US" altLang="zh-CN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SCaBP8</a:t>
            </a:r>
          </a:p>
        </p:txBody>
      </p:sp>
      <p:sp>
        <p:nvSpPr>
          <p:cNvPr id="7" name="文本框 6">
            <a:extLst>
              <a:ext uri="{FF2B5EF4-FFF2-40B4-BE49-F238E27FC236}">
                <a16:creationId xmlns="" xmlns:a16="http://schemas.microsoft.com/office/drawing/2014/main" id="{F68112DE-557F-2562-A66A-68E5DC6FCD27}"/>
              </a:ext>
            </a:extLst>
          </p:cNvPr>
          <p:cNvSpPr txBox="1"/>
          <p:nvPr/>
        </p:nvSpPr>
        <p:spPr>
          <a:xfrm>
            <a:off x="401184" y="2123665"/>
            <a:ext cx="2053193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Promoter sequence (3k)</a:t>
            </a:r>
            <a:r>
              <a:rPr lang="zh-CN" altLang="en-US" sz="1000" dirty="0"/>
              <a:t>：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="" xmlns:a16="http://schemas.microsoft.com/office/drawing/2014/main" id="{5898789F-9588-4992-BECD-454872461B18}"/>
              </a:ext>
            </a:extLst>
          </p:cNvPr>
          <p:cNvSpPr txBox="1"/>
          <p:nvPr/>
        </p:nvSpPr>
        <p:spPr>
          <a:xfrm>
            <a:off x="140008" y="936172"/>
            <a:ext cx="252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="" xmlns:a16="http://schemas.microsoft.com/office/drawing/2014/main" id="{C18EC875-580E-8AA5-4B03-1466F829F83F}"/>
              </a:ext>
            </a:extLst>
          </p:cNvPr>
          <p:cNvSpPr txBox="1"/>
          <p:nvPr/>
        </p:nvSpPr>
        <p:spPr>
          <a:xfrm>
            <a:off x="140008" y="2094875"/>
            <a:ext cx="252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="" xmlns:a16="http://schemas.microsoft.com/office/drawing/2014/main" id="{A8838C53-A831-71F6-7F26-84E878B3078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229" y="2530602"/>
            <a:ext cx="6128477" cy="3921835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="" xmlns:a16="http://schemas.microsoft.com/office/drawing/2014/main" id="{96CEB41B-BD80-8C87-947E-044CA92C899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444" y="1400759"/>
            <a:ext cx="6128476" cy="504468"/>
          </a:xfrm>
          <a:prstGeom prst="rect">
            <a:avLst/>
          </a:prstGeom>
        </p:spPr>
      </p:pic>
      <p:sp>
        <p:nvSpPr>
          <p:cNvPr id="2" name="矩形 1"/>
          <p:cNvSpPr/>
          <p:nvPr/>
        </p:nvSpPr>
        <p:spPr>
          <a:xfrm>
            <a:off x="496868" y="6724173"/>
            <a:ext cx="5864263" cy="28931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3 Sequence variations in amino acids and promoter of</a:t>
            </a:r>
            <a:r>
              <a:rPr lang="en-US" altLang="zh-CN" sz="14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lSCaBP8</a:t>
            </a:r>
            <a:endParaRPr lang="zh-CN" altLang="zh-CN" sz="14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The multiple alignment analysis of SlSCaBP8 proteins. Full-length amino acid sequences alignment of SCaBP8 of </a:t>
            </a:r>
            <a:r>
              <a:rPr lang="en-US" altLang="zh-CN" sz="14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. </a:t>
            </a:r>
            <a:r>
              <a:rPr lang="en-US" altLang="zh-CN" sz="1400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impinellifolium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LA1589), </a:t>
            </a:r>
            <a:r>
              <a:rPr lang="en-US" altLang="zh-CN" sz="14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. </a:t>
            </a:r>
            <a:r>
              <a:rPr lang="en-US" altLang="zh-CN" sz="1400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ycopersicum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E6203) and </a:t>
            </a:r>
            <a:r>
              <a:rPr lang="en-US" altLang="zh-CN" sz="14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. </a:t>
            </a:r>
            <a:r>
              <a:rPr lang="en-US" altLang="zh-CN" sz="1400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ycopersicum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M82). The analysis was performed using </a:t>
            </a:r>
            <a:r>
              <a:rPr lang="en-US" altLang="zh-CN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afft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with defaults by </a:t>
            </a:r>
            <a:r>
              <a:rPr lang="en-US" altLang="zh-CN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Jalview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Dark blue shading and light blue shading respectively indicate identity and similarity among SCaBP8</a:t>
            </a:r>
            <a:r>
              <a:rPr lang="en-US" altLang="zh-CN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A1589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SCaBP8</a:t>
            </a:r>
            <a:r>
              <a:rPr lang="en-US" altLang="zh-CN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6203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nd SCaBP8</a:t>
            </a:r>
            <a:r>
              <a:rPr lang="en-US" altLang="zh-CN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82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4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 The multiple alignment analysis of </a:t>
            </a:r>
            <a:r>
              <a:rPr lang="en-US" altLang="zh-CN" sz="14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lSCaBP8 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romoters. Promoter sequence (3 kb upstream of the start codon) alignment of the SCaBP8</a:t>
            </a:r>
            <a:r>
              <a:rPr lang="en-US" altLang="zh-CN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A1589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SCaBP8</a:t>
            </a:r>
            <a:r>
              <a:rPr lang="en-US" altLang="zh-CN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6203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nd SCaBP8</a:t>
            </a:r>
            <a:r>
              <a:rPr lang="en-US" altLang="zh-CN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82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The analysis was performed using </a:t>
            </a:r>
            <a:r>
              <a:rPr lang="en-US" altLang="zh-CN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afft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with defaults by </a:t>
            </a:r>
            <a:r>
              <a:rPr lang="en-US" altLang="zh-CN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Jalview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 Dark blue shading and light blue shading respectively indicate identity and similarity among SCaBP8</a:t>
            </a:r>
            <a:r>
              <a:rPr lang="en-US" altLang="zh-CN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A1589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SCaBP8</a:t>
            </a:r>
            <a:r>
              <a:rPr lang="en-US" altLang="zh-CN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6203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and SCaBP8</a:t>
            </a:r>
            <a:r>
              <a:rPr lang="en-US" altLang="zh-CN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M82</a:t>
            </a:r>
            <a:r>
              <a:rPr lang="en-US" altLang="zh-CN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48928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="" xmlns:a16="http://schemas.microsoft.com/office/drawing/2014/main" id="{FB15528D-2D3B-4B08-B712-27968F29EAB7}"/>
              </a:ext>
            </a:extLst>
          </p:cNvPr>
          <p:cNvSpPr/>
          <p:nvPr/>
        </p:nvSpPr>
        <p:spPr>
          <a:xfrm>
            <a:off x="442009" y="501618"/>
            <a:ext cx="554143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Distribution of tomato accessions  </a:t>
            </a:r>
            <a:endParaRPr lang="en-US" altLang="zh-CN" sz="14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="" xmlns:a16="http://schemas.microsoft.com/office/drawing/2014/main" id="{F6DD048B-D59F-4E4D-A6D6-E54EEA1BAD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5238" y="1321553"/>
            <a:ext cx="2290887" cy="1839505"/>
          </a:xfrm>
          <a:prstGeom prst="rect">
            <a:avLst/>
          </a:prstGeom>
        </p:spPr>
      </p:pic>
      <p:sp>
        <p:nvSpPr>
          <p:cNvPr id="2" name="矩形 1"/>
          <p:cNvSpPr/>
          <p:nvPr/>
        </p:nvSpPr>
        <p:spPr>
          <a:xfrm>
            <a:off x="511144" y="3712102"/>
            <a:ext cx="569064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4. Distribution of tomato accessions  </a:t>
            </a:r>
            <a:endParaRPr lang="zh-CN" altLang="zh-CN" sz="140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lvl="0" algn="just">
              <a:spcAft>
                <a:spcPts val="0"/>
              </a:spcAft>
            </a:pP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istribution of 706 accessions, including 76 PIM, 254 CER, and 376 BIG.</a:t>
            </a:r>
            <a:endParaRPr lang="zh-CN" alt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08905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="" xmlns:a16="http://schemas.microsoft.com/office/drawing/2014/main" id="{F0C15D93-F02C-4FF1-BE17-FCED4DD595FA}"/>
              </a:ext>
            </a:extLst>
          </p:cNvPr>
          <p:cNvSpPr/>
          <p:nvPr/>
        </p:nvSpPr>
        <p:spPr>
          <a:xfrm>
            <a:off x="442009" y="501618"/>
            <a:ext cx="554143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SNP7 potentially impacts the expression of </a:t>
            </a:r>
            <a:r>
              <a:rPr lang="en-US" altLang="zh-CN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SCaBP8  </a:t>
            </a:r>
          </a:p>
        </p:txBody>
      </p:sp>
      <p:sp>
        <p:nvSpPr>
          <p:cNvPr id="2" name="矩形 1">
            <a:extLst>
              <a:ext uri="{FF2B5EF4-FFF2-40B4-BE49-F238E27FC236}">
                <a16:creationId xmlns="" xmlns:a16="http://schemas.microsoft.com/office/drawing/2014/main" id="{B0E264F1-5DD7-4382-A1D2-044610BF062C}"/>
              </a:ext>
            </a:extLst>
          </p:cNvPr>
          <p:cNvSpPr/>
          <p:nvPr/>
        </p:nvSpPr>
        <p:spPr>
          <a:xfrm>
            <a:off x="542924" y="4622778"/>
            <a:ext cx="5632107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SNP7 potentially impacts the expression of </a:t>
            </a:r>
            <a:r>
              <a:rPr lang="en-US" altLang="zh-CN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SCaBP8 </a:t>
            </a:r>
            <a:endParaRPr lang="en-US" altLang="zh-CN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ient expression assay of promoter activity. 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experiments were performed with three biological replicates with similar results. Statistical signiﬁcance was determined by one-way ANOVA, P &lt; 0.05. Signiﬁcant differences are indicated by different lowercase letters. </a:t>
            </a:r>
          </a:p>
        </p:txBody>
      </p:sp>
      <p:pic>
        <p:nvPicPr>
          <p:cNvPr id="6" name="图片 5">
            <a:extLst>
              <a:ext uri="{FF2B5EF4-FFF2-40B4-BE49-F238E27FC236}">
                <a16:creationId xmlns="" xmlns:a16="http://schemas.microsoft.com/office/drawing/2014/main" id="{D7880D51-6220-49D0-BDF5-C5D1717975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03174" y="1590215"/>
            <a:ext cx="4651651" cy="27495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48729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2776</TotalTime>
  <Words>556</Words>
  <Application>Microsoft Office PowerPoint</Application>
  <PresentationFormat>A4 纸张(210x297 毫米)</PresentationFormat>
  <Paragraphs>46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5" baseType="lpstr">
      <vt:lpstr>等线</vt:lpstr>
      <vt:lpstr>等线 Light</vt:lpstr>
      <vt:lpstr>黑体</vt:lpstr>
      <vt:lpstr>华文宋体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atural variation in SlSCaBP8/SlCBL10 contribute to the loss of salt-alkali tolerance during tomato improvement</dc:title>
  <dc:creator>刘 健</dc:creator>
  <cp:lastModifiedBy>LENOVO</cp:lastModifiedBy>
  <cp:revision>319</cp:revision>
  <dcterms:created xsi:type="dcterms:W3CDTF">2023-02-14T17:25:53Z</dcterms:created>
  <dcterms:modified xsi:type="dcterms:W3CDTF">2024-01-18T14:09:18Z</dcterms:modified>
</cp:coreProperties>
</file>